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6" autoAdjust="0"/>
    <p:restoredTop sz="94660"/>
  </p:normalViewPr>
  <p:slideViewPr>
    <p:cSldViewPr snapToGrid="0">
      <p:cViewPr varScale="1">
        <p:scale>
          <a:sx n="66" d="100"/>
          <a:sy n="66" d="100"/>
        </p:scale>
        <p:origin x="628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emertzidou, Anysia" userId="a7f71f62-1794-4728-88f7-f0b545a7c8aa" providerId="ADAL" clId="{F99CD868-3E3F-4A8D-A146-1DE7117A8B06}"/>
    <pc:docChg chg="modSld">
      <pc:chgData name="Semertzidou, Anysia" userId="a7f71f62-1794-4728-88f7-f0b545a7c8aa" providerId="ADAL" clId="{F99CD868-3E3F-4A8D-A146-1DE7117A8B06}" dt="2025-10-30T16:07:16.649" v="17" actId="113"/>
      <pc:docMkLst>
        <pc:docMk/>
      </pc:docMkLst>
      <pc:sldChg chg="addSp modSp mod">
        <pc:chgData name="Semertzidou, Anysia" userId="a7f71f62-1794-4728-88f7-f0b545a7c8aa" providerId="ADAL" clId="{F99CD868-3E3F-4A8D-A146-1DE7117A8B06}" dt="2025-10-30T16:07:16.649" v="17" actId="113"/>
        <pc:sldMkLst>
          <pc:docMk/>
          <pc:sldMk cId="1287654078" sldId="256"/>
        </pc:sldMkLst>
        <pc:spChg chg="add mod">
          <ac:chgData name="Semertzidou, Anysia" userId="a7f71f62-1794-4728-88f7-f0b545a7c8aa" providerId="ADAL" clId="{F99CD868-3E3F-4A8D-A146-1DE7117A8B06}" dt="2025-10-30T16:06:58.607" v="14" actId="113"/>
          <ac:spMkLst>
            <pc:docMk/>
            <pc:sldMk cId="1287654078" sldId="256"/>
            <ac:spMk id="3" creationId="{987AA395-7118-8D8D-AAF5-E1D490CC1C00}"/>
          </ac:spMkLst>
        </pc:spChg>
        <pc:spChg chg="add mod">
          <ac:chgData name="Semertzidou, Anysia" userId="a7f71f62-1794-4728-88f7-f0b545a7c8aa" providerId="ADAL" clId="{F99CD868-3E3F-4A8D-A146-1DE7117A8B06}" dt="2025-10-30T16:07:16.649" v="17" actId="113"/>
          <ac:spMkLst>
            <pc:docMk/>
            <pc:sldMk cId="1287654078" sldId="256"/>
            <ac:spMk id="9" creationId="{9BDB689C-AA23-BFDA-5BFA-13609E9C55CB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6ABAF4-1AAE-58CC-B355-4A74E6C05D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ADBA173-C6F2-B283-EA6C-EFA7465087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98911E-A951-3A4A-7150-A326A0C5E4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0FFFC-137F-4CCB-B2CA-5A8BF15BD6E4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0DE65F-5C56-171A-CD4A-9BD62E7E3D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C83889-52CA-56DE-21BD-B4C62C36EC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895CB-403C-45C9-B92C-F7416B881A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62967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23BD78-CDC9-7C2D-1D1E-C061DEFA4D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C48BBA-E682-B58E-DC66-73DCDFCDE2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DBDF7F-8D2C-EF05-2CAE-14F6E62979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0FFFC-137F-4CCB-B2CA-5A8BF15BD6E4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C8BE2B-F32C-C23D-0A2F-4ECE21E61A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05046A-6DCE-1897-AAF5-81DC1367F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895CB-403C-45C9-B92C-F7416B881A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34872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08E3803-F48E-6452-5510-498B3E94539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8E071CD-E371-2723-E041-3C007A37B9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91F5AC-C9F6-2078-0698-E42E9BCCB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0FFFC-137F-4CCB-B2CA-5A8BF15BD6E4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9F2EA1-95BF-B519-D6F5-8EE981CC81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3C427B-2676-DCBB-1932-1797749E0A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895CB-403C-45C9-B92C-F7416B881A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98156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22B95E-1589-456C-03C4-1DA5A14463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A52C4D-29CC-B48F-71A9-6467C174D5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82436C-9941-A409-3B17-CF6590B504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0FFFC-137F-4CCB-B2CA-5A8BF15BD6E4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CFAE11-90C2-733E-71FC-F0A0426138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176708-2B0A-F027-6AFC-6EA91A5E76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895CB-403C-45C9-B92C-F7416B881A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80893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A10D62-BFAD-B161-5F98-EF8BD2EDDA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9D04AA-4053-8956-38EE-537091AB94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7B8370-4713-F915-BFD9-E6F1AA1F3C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0FFFC-137F-4CCB-B2CA-5A8BF15BD6E4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AB6E1B-E8CE-65DD-F06A-4A19E7E2FB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527C7B-A030-265A-F6C3-CFC4039C33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895CB-403C-45C9-B92C-F7416B881A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15132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A7037D-E33A-3420-4FA1-F5FFD7249B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2010F8-A37E-1248-89CF-E58710483FB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FB3894-AEEB-60FC-078F-74431BFA6C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962BC8-D5B6-BC65-5CC4-566027D087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0FFFC-137F-4CCB-B2CA-5A8BF15BD6E4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8E27C2-AD6A-E4A6-FBD9-6D2C814AEC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753D90-21BD-E96C-BF12-422828D4C6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895CB-403C-45C9-B92C-F7416B881A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6310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46BA5F-7954-8CF3-3EDE-1EAD449BB7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B769F6-0C14-753E-F526-B9794014E6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4AE37C-9A05-8CE1-1C34-CC9CAEA1C1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C964803-8EFC-2C4E-FBA4-4E818DB60B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85837B8-745A-0B9F-0340-57322ED9FE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37C86D7-88E8-6B4F-2CAA-B6E3FB6AEB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0FFFC-137F-4CCB-B2CA-5A8BF15BD6E4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B92F743-2247-BCC2-5DED-28A445658A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159934F-4F38-EFB6-7CD2-2361CEF9ED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895CB-403C-45C9-B92C-F7416B881A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40898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DE3EEC-BCB9-F981-1FF3-3C17C33A70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B5FD627-2AD5-72B9-5326-2777E2E927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0FFFC-137F-4CCB-B2CA-5A8BF15BD6E4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3C9AE46-7B0C-327E-07EC-73B72BEB69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8600C4A-ED26-3A32-1946-5756E36060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895CB-403C-45C9-B92C-F7416B881A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02601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E94CD8F-7111-E166-DE40-01A2047BD5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0FFFC-137F-4CCB-B2CA-5A8BF15BD6E4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DF2812A-32F6-21A3-4EA6-F6AE03F5C5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F83F7CC-EFC9-3966-4028-5A8AE51DFF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895CB-403C-45C9-B92C-F7416B881A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74662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4A32D3-5F63-2FE4-52CF-A2D69467B7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D03228-E741-6F28-F34D-A084F752EF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B9C1BE-2FD9-EF78-0697-F688BC8759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8E6618-4608-4887-99DF-F0277C5F9A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0FFFC-137F-4CCB-B2CA-5A8BF15BD6E4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6E41AF-0D3B-22D1-F86D-09774D2BBE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C85F38-EE2E-DEB0-3512-6064E2572E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895CB-403C-45C9-B92C-F7416B881A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51468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330294-63B6-897F-D709-F75EDBE3A2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D9DD3AD-990A-883E-B04D-CB5C6296051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585451-F2BA-2EAE-B3AB-F91AA71296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9AC987-0166-9DF1-A422-3C6294B219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0FFFC-137F-4CCB-B2CA-5A8BF15BD6E4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3CD81D-DD7E-1BC9-14C4-B7E60E17F7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43E9D1-0B16-60E1-02FF-5D5444CDAC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895CB-403C-45C9-B92C-F7416B881A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84627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9569B35-B481-4674-A278-511FD34548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58B2DA-0FF4-FFF2-4202-4A57BFD236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F30639-F577-F3DF-D2C9-18A3F3B2AE6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F0FFFC-137F-4CCB-B2CA-5A8BF15BD6E4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BEC108-CC64-3978-3BF7-C878ADD599E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480D76-9471-2830-DD3A-BB0E1BB8DB7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BF895CB-403C-45C9-B92C-F7416B881A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7526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3CE4A8F6-6C86-CBEF-DD57-849F029602D0}"/>
              </a:ext>
            </a:extLst>
          </p:cNvPr>
          <p:cNvGrpSpPr/>
          <p:nvPr/>
        </p:nvGrpSpPr>
        <p:grpSpPr>
          <a:xfrm>
            <a:off x="2437029" y="1630497"/>
            <a:ext cx="7522219" cy="2875402"/>
            <a:chOff x="0" y="0"/>
            <a:chExt cx="5731510" cy="1778000"/>
          </a:xfrm>
        </p:grpSpPr>
        <p:pic>
          <p:nvPicPr>
            <p:cNvPr id="5" name="Picture 4" descr="A collage of images of different colored shapes&#10;&#10;Description automatically generated">
              <a:extLst>
                <a:ext uri="{FF2B5EF4-FFF2-40B4-BE49-F238E27FC236}">
                  <a16:creationId xmlns:a16="http://schemas.microsoft.com/office/drawing/2014/main" id="{33A23066-0888-B197-4115-8BF9E028AAD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0"/>
              <a:ext cx="5731510" cy="1778000"/>
            </a:xfrm>
            <a:prstGeom prst="rect">
              <a:avLst/>
            </a:prstGeom>
          </p:spPr>
        </p:pic>
        <p:sp>
          <p:nvSpPr>
            <p:cNvPr id="6" name="Text Box 14">
              <a:extLst>
                <a:ext uri="{FF2B5EF4-FFF2-40B4-BE49-F238E27FC236}">
                  <a16:creationId xmlns:a16="http://schemas.microsoft.com/office/drawing/2014/main" id="{347F5DE3-0024-FA1E-C8A4-26EBB876B70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5319" y="1270660"/>
              <a:ext cx="853439" cy="3917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GB" sz="1200" kern="100">
                  <a:effectLst/>
                  <a:latin typeface="Arial" panose="020B0604020202020204" pitchFamily="34" charset="0"/>
                  <a:ea typeface="Yu Mincho" panose="02020400000000000000" pitchFamily="18" charset="-128"/>
                  <a:cs typeface="Arial" panose="020B0604020202020204" pitchFamily="34" charset="0"/>
                </a:rPr>
                <a:t>p = 0.003</a:t>
              </a:r>
              <a:endParaRPr lang="en-GB" sz="1100" kern="100">
                <a:effectLst/>
                <a:latin typeface="Calibri" panose="020F0502020204030204" pitchFamily="34" charset="0"/>
                <a:ea typeface="Yu Mincho" panose="02020400000000000000" pitchFamily="18" charset="-128"/>
                <a:cs typeface="Arial" panose="020B0604020202020204" pitchFamily="34" charset="0"/>
              </a:endParaRPr>
            </a:p>
          </p:txBody>
        </p:sp>
        <p:sp>
          <p:nvSpPr>
            <p:cNvPr id="7" name="Text Box 17">
              <a:extLst>
                <a:ext uri="{FF2B5EF4-FFF2-40B4-BE49-F238E27FC236}">
                  <a16:creationId xmlns:a16="http://schemas.microsoft.com/office/drawing/2014/main" id="{E234499C-2CB3-0E0B-904C-ECE2C27196B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51958" y="1270660"/>
              <a:ext cx="853439" cy="3917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GB" sz="1200" kern="100">
                  <a:effectLst/>
                  <a:latin typeface="Arial" panose="020B0604020202020204" pitchFamily="34" charset="0"/>
                  <a:ea typeface="Yu Mincho" panose="02020400000000000000" pitchFamily="18" charset="-128"/>
                  <a:cs typeface="Arial" panose="020B0604020202020204" pitchFamily="34" charset="0"/>
                </a:rPr>
                <a:t>p = 0.008</a:t>
              </a:r>
              <a:endParaRPr lang="en-GB" sz="1100" kern="100">
                <a:effectLst/>
                <a:latin typeface="Calibri" panose="020F0502020204030204" pitchFamily="34" charset="0"/>
                <a:ea typeface="Yu Mincho" panose="02020400000000000000" pitchFamily="18" charset="-128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987AA395-7118-8D8D-AAF5-E1D490CC1C00}"/>
              </a:ext>
            </a:extLst>
          </p:cNvPr>
          <p:cNvSpPr txBox="1"/>
          <p:nvPr/>
        </p:nvSpPr>
        <p:spPr>
          <a:xfrm>
            <a:off x="2548288" y="4668162"/>
            <a:ext cx="7510112" cy="66223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5000"/>
              </a:lnSpc>
              <a:spcAft>
                <a:spcPts val="800"/>
              </a:spcAft>
            </a:pPr>
            <a:r>
              <a:rPr lang="en-US" sz="1800" i="1" kern="1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Calibri" panose="020F0502020204030204" pitchFamily="34" charset="0"/>
              </a:rPr>
              <a:t>Supplementary Figure 2</a:t>
            </a:r>
            <a:r>
              <a:rPr lang="en-US" i="1" kern="100" dirty="0">
                <a:latin typeface="Calibri" panose="020F0502020204030204" pitchFamily="34" charset="0"/>
                <a:ea typeface="Yu Mincho" panose="02020400000000000000" pitchFamily="18" charset="-128"/>
                <a:cs typeface="Calibri" panose="020F0502020204030204" pitchFamily="34" charset="0"/>
              </a:rPr>
              <a:t> shows o</a:t>
            </a:r>
            <a:r>
              <a:rPr lang="en-US" sz="1800" i="1" kern="1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Calibri" panose="020F0502020204030204" pitchFamily="34" charset="0"/>
              </a:rPr>
              <a:t>verall survival (a) and progression-free survival (b) curves for patients stratified by COLL1A1 expression.</a:t>
            </a:r>
            <a:endParaRPr lang="en-GB" sz="1800" kern="1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BDB689C-AA23-BFDA-5BFA-13609E9C55CB}"/>
              </a:ext>
            </a:extLst>
          </p:cNvPr>
          <p:cNvSpPr txBox="1"/>
          <p:nvPr/>
        </p:nvSpPr>
        <p:spPr>
          <a:xfrm>
            <a:off x="2365408" y="1013679"/>
            <a:ext cx="60976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1" kern="1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Calibri" panose="020F0502020204030204" pitchFamily="34" charset="0"/>
              </a:rPr>
              <a:t>Supplementary Figure 2</a:t>
            </a:r>
            <a:r>
              <a:rPr lang="en-US" b="1" i="1" kern="100" dirty="0">
                <a:latin typeface="Calibri" panose="020F0502020204030204" pitchFamily="34" charset="0"/>
                <a:ea typeface="Yu Mincho" panose="02020400000000000000" pitchFamily="18" charset="-128"/>
                <a:cs typeface="Calibri" panose="020F0502020204030204" pitchFamily="34" charset="0"/>
              </a:rPr>
              <a:t> 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12876540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32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emertzidou, Anysia</dc:creator>
  <cp:lastModifiedBy>Semertzidou, Anysia</cp:lastModifiedBy>
  <cp:revision>1</cp:revision>
  <dcterms:created xsi:type="dcterms:W3CDTF">2025-10-06T13:12:47Z</dcterms:created>
  <dcterms:modified xsi:type="dcterms:W3CDTF">2025-10-30T16:07:19Z</dcterms:modified>
</cp:coreProperties>
</file>